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3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400" y="767880"/>
            <a:ext cx="287640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9000" rIns="99000" tIns="49680" bIns="49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D7D4C1-D5BD-4C75-9DF7-4249331AAF9F}" type="slidenum">
              <a:rPr b="0" lang="ja-JP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6400" cy="3837240"/>
          </a:xfrm>
          <a:prstGeom prst="rect">
            <a:avLst/>
          </a:prstGeom>
          <a:ln w="0">
            <a:noFill/>
          </a:ln>
        </p:spPr>
      </p:sp>
      <p:sp>
        <p:nvSpPr>
          <p:cNvPr id="121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スライド番号プレースホルダ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3D8A82-6DA5-499F-8A04-263D0259B2CB}" type="slidenum">
              <a:rPr b="0" lang="ja-JP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6400" cy="3837240"/>
          </a:xfrm>
          <a:prstGeom prst="rect">
            <a:avLst/>
          </a:prstGeom>
          <a:ln w="0">
            <a:noFill/>
          </a:ln>
        </p:spPr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スライド番号プレースホルダ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B3C87B-162F-4A82-B224-856E9F2523E5}" type="slidenum">
              <a:rPr b="0" lang="ja-JP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6400" cy="3837240"/>
          </a:xfrm>
          <a:prstGeom prst="rect">
            <a:avLst/>
          </a:prstGeom>
          <a:ln w="0">
            <a:noFill/>
          </a:ln>
        </p:spPr>
      </p:sp>
      <p:sp>
        <p:nvSpPr>
          <p:cNvPr id="127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スライド番号プレースホルダ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73921E-0664-41CC-9E94-FD7EBF4DF96E}" type="slidenum">
              <a:rPr b="0" lang="ja-JP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AF22DB-3A2F-49CE-9CA1-27461A216C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5B5D6B-4E70-4A4E-A433-A1CB818564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20B2E8-B9C9-4626-9E0F-B27D576502C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FF7CAF-218D-4593-B34F-232088948C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D7022-33AA-4FD4-9E20-ABF9024529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8736B-F39D-4BB5-B094-523AD0227F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19141-D3FD-4B11-9DE0-168BF14207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AA961-E6C8-47B0-8851-18A925CAB5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5DFAF2-48D1-47CB-B90C-E7C0E8375A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64EA4-E45F-4E73-BCFF-3FDB8EABE5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AA82D4-417E-4C6F-8AEA-325A3B6623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FEA096-08D8-4D86-B012-30EE396E51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365B60-127B-4902-B6F6-BE02B86F33E3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3"/>
          <p:cNvSpPr/>
          <p:nvPr/>
        </p:nvSpPr>
        <p:spPr>
          <a:xfrm>
            <a:off x="476280" y="2411280"/>
            <a:ext cx="55450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Calibri"/>
              </a:rPr>
              <a:t>Additional file 1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4"/>
          <p:cNvSpPr/>
          <p:nvPr/>
        </p:nvSpPr>
        <p:spPr>
          <a:xfrm>
            <a:off x="557280" y="3106800"/>
            <a:ext cx="56163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533520" indent="-53352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1.1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Workflow of large-scale proteomic analysis of normal human kidney glomerul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533520" indent="-53352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1.2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Detailed procedure of LC-MS/MS analysi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5"/>
          <p:cNvSpPr/>
          <p:nvPr/>
        </p:nvSpPr>
        <p:spPr>
          <a:xfrm>
            <a:off x="3933720" y="8317080"/>
            <a:ext cx="266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dditional fi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ui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グループ化 51"/>
          <p:cNvGrpSpPr/>
          <p:nvPr/>
        </p:nvGrpSpPr>
        <p:grpSpPr>
          <a:xfrm>
            <a:off x="765000" y="468360"/>
            <a:ext cx="5205600" cy="8280360"/>
            <a:chOff x="765000" y="468360"/>
            <a:chExt cx="5205600" cy="8280360"/>
          </a:xfrm>
        </p:grpSpPr>
        <p:sp>
          <p:nvSpPr>
            <p:cNvPr id="52" name="直線コネクタ 50"/>
            <p:cNvSpPr/>
            <p:nvPr/>
          </p:nvSpPr>
          <p:spPr>
            <a:xfrm>
              <a:off x="3311280" y="2797200"/>
              <a:ext cx="0" cy="2973240"/>
            </a:xfrm>
            <a:prstGeom prst="line">
              <a:avLst/>
            </a:prstGeom>
            <a:ln w="12600">
              <a:solidFill>
                <a:srgbClr val="000000"/>
              </a:solidFill>
              <a:prstDash val="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テキスト ボックス 1"/>
            <p:cNvSpPr/>
            <p:nvPr/>
          </p:nvSpPr>
          <p:spPr>
            <a:xfrm>
              <a:off x="2434680" y="1377360"/>
              <a:ext cx="180000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Purified glomerul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テキスト ボックス 2"/>
            <p:cNvSpPr/>
            <p:nvPr/>
          </p:nvSpPr>
          <p:spPr>
            <a:xfrm>
              <a:off x="2427480" y="2019240"/>
              <a:ext cx="180000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Protein extract (2 mg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テキスト ボックス 3"/>
            <p:cNvSpPr/>
            <p:nvPr/>
          </p:nvSpPr>
          <p:spPr>
            <a:xfrm>
              <a:off x="2434680" y="642240"/>
              <a:ext cx="180000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Human kidney corte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6" name="直線矢印コネクタ 4"/>
            <p:cNvCxnSpPr/>
            <p:nvPr/>
          </p:nvCxnSpPr>
          <p:spPr>
            <a:xfrm>
              <a:off x="3331800" y="1022400"/>
              <a:ext cx="1080" cy="288000"/>
            </a:xfrm>
            <a:prstGeom prst="straightConnector1">
              <a:avLst/>
            </a:prstGeom>
            <a:ln w="316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7" name="テキスト ボックス 5"/>
            <p:cNvSpPr/>
            <p:nvPr/>
          </p:nvSpPr>
          <p:spPr>
            <a:xfrm>
              <a:off x="3356280" y="932760"/>
              <a:ext cx="1512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Sieving with stainless steel sieves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8" name="直線矢印コネクタ 6"/>
            <p:cNvCxnSpPr/>
            <p:nvPr/>
          </p:nvCxnSpPr>
          <p:spPr>
            <a:xfrm>
              <a:off x="3315960" y="1750680"/>
              <a:ext cx="1080" cy="207000"/>
            </a:xfrm>
            <a:prstGeom prst="straightConnector1">
              <a:avLst/>
            </a:prstGeom>
            <a:ln w="316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9" name="テキスト ボックス 7"/>
            <p:cNvSpPr/>
            <p:nvPr/>
          </p:nvSpPr>
          <p:spPr>
            <a:xfrm>
              <a:off x="2486520" y="2568960"/>
              <a:ext cx="165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Reduction/alkyl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0" name="直線矢印コネクタ 8"/>
            <p:cNvCxnSpPr/>
            <p:nvPr/>
          </p:nvCxnSpPr>
          <p:spPr>
            <a:xfrm>
              <a:off x="3312720" y="2373120"/>
              <a:ext cx="1080" cy="205200"/>
            </a:xfrm>
            <a:prstGeom prst="straightConnector1">
              <a:avLst/>
            </a:prstGeom>
            <a:ln w="31680">
              <a:solidFill>
                <a:srgbClr val="000000"/>
              </a:solidFill>
              <a:miter/>
              <a:tailEnd len="med" type="triangle" w="med"/>
            </a:ln>
          </p:spPr>
        </p:cxnSp>
        <p:pic>
          <p:nvPicPr>
            <p:cNvPr id="61" name="Picture 4" descr=""/>
            <p:cNvPicPr/>
            <p:nvPr/>
          </p:nvPicPr>
          <p:blipFill>
            <a:blip r:embed="rId1"/>
            <a:stretch/>
          </p:blipFill>
          <p:spPr>
            <a:xfrm>
              <a:off x="3589560" y="3262320"/>
              <a:ext cx="1800000" cy="649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テキスト ボックス 10"/>
            <p:cNvSpPr/>
            <p:nvPr/>
          </p:nvSpPr>
          <p:spPr>
            <a:xfrm>
              <a:off x="837000" y="2873520"/>
              <a:ext cx="2016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600" spc="-1" strike="noStrike">
                  <a:solidFill>
                    <a:srgbClr val="0070c0"/>
                  </a:solidFill>
                  <a:latin typeface="Calibri"/>
                </a:rPr>
                <a:t>1-D prefractiona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テキスト ボックス 11"/>
            <p:cNvSpPr/>
            <p:nvPr/>
          </p:nvSpPr>
          <p:spPr>
            <a:xfrm>
              <a:off x="3907440" y="2873520"/>
              <a:ext cx="2016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600" spc="-1" strike="noStrike">
                  <a:solidFill>
                    <a:srgbClr val="0070c0"/>
                  </a:solidFill>
                  <a:latin typeface="Calibri"/>
                </a:rPr>
                <a:t>2-D prefractiona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4" name="Picture 6" descr=""/>
            <p:cNvPicPr/>
            <p:nvPr/>
          </p:nvPicPr>
          <p:blipFill>
            <a:blip r:embed="rId2"/>
            <a:stretch/>
          </p:blipFill>
          <p:spPr>
            <a:xfrm>
              <a:off x="2097360" y="4006440"/>
              <a:ext cx="231480" cy="100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7" descr=""/>
            <p:cNvPicPr/>
            <p:nvPr/>
          </p:nvPicPr>
          <p:blipFill>
            <a:blip r:embed="rId3"/>
            <a:stretch/>
          </p:blipFill>
          <p:spPr>
            <a:xfrm>
              <a:off x="3938760" y="4006440"/>
              <a:ext cx="1146240" cy="100800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66" name="直線矢印コネクタ 14"/>
            <p:cNvCxnSpPr/>
            <p:nvPr/>
          </p:nvCxnSpPr>
          <p:spPr>
            <a:xfrm>
              <a:off x="3362040" y="2833560"/>
              <a:ext cx="283320" cy="321120"/>
            </a:xfrm>
            <a:prstGeom prst="straightConnector1">
              <a:avLst/>
            </a:prstGeom>
            <a:ln w="316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7" name="直線矢印コネクタ 15"/>
            <p:cNvCxnSpPr/>
            <p:nvPr/>
          </p:nvCxnSpPr>
          <p:spPr>
            <a:xfrm flipH="1">
              <a:off x="2419920" y="2833200"/>
              <a:ext cx="835560" cy="999000"/>
            </a:xfrm>
            <a:prstGeom prst="straightConnector1">
              <a:avLst/>
            </a:prstGeom>
            <a:ln w="316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8" name="テキスト ボックス 16"/>
            <p:cNvSpPr/>
            <p:nvPr/>
          </p:nvSpPr>
          <p:spPr>
            <a:xfrm>
              <a:off x="3706200" y="3128400"/>
              <a:ext cx="18000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Solution phase IEF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テキスト ボックス 17"/>
            <p:cNvSpPr/>
            <p:nvPr/>
          </p:nvSpPr>
          <p:spPr>
            <a:xfrm>
              <a:off x="4971240" y="4670640"/>
              <a:ext cx="93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SDS-PA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テキスト ボックス 18"/>
            <p:cNvSpPr/>
            <p:nvPr/>
          </p:nvSpPr>
          <p:spPr>
            <a:xfrm>
              <a:off x="2240280" y="4712760"/>
              <a:ext cx="93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SDS-PA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直線コネクタ 21"/>
            <p:cNvSpPr/>
            <p:nvPr/>
          </p:nvSpPr>
          <p:spPr>
            <a:xfrm>
              <a:off x="765000" y="468360"/>
              <a:ext cx="0" cy="828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テキスト ボックス 22"/>
            <p:cNvSpPr/>
            <p:nvPr/>
          </p:nvSpPr>
          <p:spPr>
            <a:xfrm>
              <a:off x="1719360" y="5498280"/>
              <a:ext cx="93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15 fraction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テキスト ボックス 23"/>
            <p:cNvSpPr/>
            <p:nvPr/>
          </p:nvSpPr>
          <p:spPr>
            <a:xfrm>
              <a:off x="4102560" y="5504400"/>
              <a:ext cx="93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75 fraction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テキスト ボックス 24"/>
            <p:cNvSpPr/>
            <p:nvPr/>
          </p:nvSpPr>
          <p:spPr>
            <a:xfrm>
              <a:off x="2175480" y="5933520"/>
              <a:ext cx="227016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In-gel trypsin digest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テキスト ボックス 25"/>
            <p:cNvSpPr/>
            <p:nvPr/>
          </p:nvSpPr>
          <p:spPr>
            <a:xfrm>
              <a:off x="2179800" y="6568920"/>
              <a:ext cx="227016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nLC-ESI-iontrap MS/M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テキスト ボックス 26"/>
            <p:cNvSpPr/>
            <p:nvPr/>
          </p:nvSpPr>
          <p:spPr>
            <a:xfrm>
              <a:off x="2565000" y="6842880"/>
              <a:ext cx="149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2-LC runs/frac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テキスト ボックス 29"/>
            <p:cNvSpPr/>
            <p:nvPr/>
          </p:nvSpPr>
          <p:spPr>
            <a:xfrm>
              <a:off x="3984120" y="7495920"/>
              <a:ext cx="158400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Spectrum Mil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テキスト ボックス 30"/>
            <p:cNvSpPr/>
            <p:nvPr/>
          </p:nvSpPr>
          <p:spPr>
            <a:xfrm>
              <a:off x="1031760" y="7495920"/>
              <a:ext cx="158400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Masco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円柱 31"/>
            <p:cNvSpPr/>
            <p:nvPr/>
          </p:nvSpPr>
          <p:spPr>
            <a:xfrm>
              <a:off x="3073320" y="7469280"/>
              <a:ext cx="504720" cy="360360"/>
            </a:xfrm>
            <a:prstGeom prst="can">
              <a:avLst>
                <a:gd name="adj" fmla="val 25000"/>
              </a:avLst>
            </a:prstGeom>
            <a:solidFill>
              <a:srgbClr val="d9d9d9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テキスト ボックス 32"/>
            <p:cNvSpPr/>
            <p:nvPr/>
          </p:nvSpPr>
          <p:spPr>
            <a:xfrm>
              <a:off x="2658240" y="7853400"/>
              <a:ext cx="1495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IPI_human datab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Ver. 3.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左右矢印 33"/>
            <p:cNvSpPr/>
            <p:nvPr/>
          </p:nvSpPr>
          <p:spPr>
            <a:xfrm>
              <a:off x="2751120" y="7577280"/>
              <a:ext cx="215640" cy="144360"/>
            </a:xfrm>
            <a:prstGeom prst="leftRightArrow">
              <a:avLst>
                <a:gd name="adj1" fmla="val 50000"/>
                <a:gd name="adj2" fmla="val 49979"/>
              </a:avLst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左右矢印 34"/>
            <p:cNvSpPr/>
            <p:nvPr/>
          </p:nvSpPr>
          <p:spPr>
            <a:xfrm>
              <a:off x="3692520" y="7577280"/>
              <a:ext cx="215640" cy="144360"/>
            </a:xfrm>
            <a:prstGeom prst="leftRightArrow">
              <a:avLst>
                <a:gd name="adj1" fmla="val 50000"/>
                <a:gd name="adj2" fmla="val 49979"/>
              </a:avLst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3" name="直線矢印コネクタ 35"/>
            <p:cNvCxnSpPr/>
            <p:nvPr/>
          </p:nvCxnSpPr>
          <p:spPr>
            <a:xfrm>
              <a:off x="3512880" y="7110000"/>
              <a:ext cx="284400" cy="322920"/>
            </a:xfrm>
            <a:prstGeom prst="straightConnector1">
              <a:avLst/>
            </a:prstGeom>
            <a:ln w="316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84" name="直線矢印コネクタ 36"/>
            <p:cNvCxnSpPr/>
            <p:nvPr/>
          </p:nvCxnSpPr>
          <p:spPr>
            <a:xfrm flipH="1">
              <a:off x="2545920" y="7110000"/>
              <a:ext cx="321120" cy="284400"/>
            </a:xfrm>
            <a:prstGeom prst="straightConnector1">
              <a:avLst/>
            </a:prstGeom>
            <a:ln w="316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85" name="テキスト ボックス 37"/>
            <p:cNvSpPr/>
            <p:nvPr/>
          </p:nvSpPr>
          <p:spPr>
            <a:xfrm>
              <a:off x="1018800" y="8155800"/>
              <a:ext cx="1601280" cy="307080"/>
            </a:xfrm>
            <a:prstGeom prst="rect">
              <a:avLst/>
            </a:prstGeom>
            <a:solidFill>
              <a:srgbClr val="00b05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ff"/>
                  </a:solidFill>
                  <a:latin typeface="Calibri"/>
                </a:rPr>
                <a:t>Identified protein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テキスト ボックス 38"/>
            <p:cNvSpPr/>
            <p:nvPr/>
          </p:nvSpPr>
          <p:spPr>
            <a:xfrm>
              <a:off x="3988440" y="8156160"/>
              <a:ext cx="1601280" cy="307080"/>
            </a:xfrm>
            <a:prstGeom prst="rect">
              <a:avLst/>
            </a:prstGeom>
            <a:solidFill>
              <a:srgbClr val="007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ff"/>
                  </a:solidFill>
                  <a:latin typeface="Calibri"/>
                </a:rPr>
                <a:t>Identified protein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下矢印 39"/>
            <p:cNvSpPr/>
            <p:nvPr/>
          </p:nvSpPr>
          <p:spPr>
            <a:xfrm>
              <a:off x="1752480" y="7875720"/>
              <a:ext cx="142560" cy="215640"/>
            </a:xfrm>
            <a:prstGeom prst="downArrow">
              <a:avLst>
                <a:gd name="adj1" fmla="val 50000"/>
                <a:gd name="adj2" fmla="val 50050"/>
              </a:avLst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下矢印 40"/>
            <p:cNvSpPr/>
            <p:nvPr/>
          </p:nvSpPr>
          <p:spPr>
            <a:xfrm>
              <a:off x="4703760" y="7863120"/>
              <a:ext cx="144360" cy="215640"/>
            </a:xfrm>
            <a:prstGeom prst="downArrow">
              <a:avLst>
                <a:gd name="adj1" fmla="val 50000"/>
                <a:gd name="adj2" fmla="val 49972"/>
              </a:avLst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直線コネクタ 42"/>
            <p:cNvSpPr/>
            <p:nvPr/>
          </p:nvSpPr>
          <p:spPr>
            <a:xfrm>
              <a:off x="5970600" y="468360"/>
              <a:ext cx="0" cy="828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直線コネクタ 44"/>
            <p:cNvSpPr/>
            <p:nvPr/>
          </p:nvSpPr>
          <p:spPr>
            <a:xfrm>
              <a:off x="777600" y="480960"/>
              <a:ext cx="5185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直線コネクタ 46"/>
            <p:cNvSpPr/>
            <p:nvPr/>
          </p:nvSpPr>
          <p:spPr>
            <a:xfrm>
              <a:off x="777600" y="2809800"/>
              <a:ext cx="5185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直線コネクタ 47"/>
            <p:cNvSpPr/>
            <p:nvPr/>
          </p:nvSpPr>
          <p:spPr>
            <a:xfrm>
              <a:off x="772920" y="5805720"/>
              <a:ext cx="5185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直線コネクタ 48"/>
            <p:cNvSpPr/>
            <p:nvPr/>
          </p:nvSpPr>
          <p:spPr>
            <a:xfrm>
              <a:off x="769680" y="8748720"/>
              <a:ext cx="518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テキスト ボックス 19"/>
            <p:cNvSpPr/>
            <p:nvPr/>
          </p:nvSpPr>
          <p:spPr>
            <a:xfrm>
              <a:off x="2179800" y="5159160"/>
              <a:ext cx="2270160" cy="307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Cut into 15 slices/lan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5" name="直線矢印コネクタ 52"/>
            <p:cNvCxnSpPr/>
            <p:nvPr/>
          </p:nvCxnSpPr>
          <p:spPr>
            <a:xfrm>
              <a:off x="3315960" y="5673600"/>
              <a:ext cx="1080" cy="207000"/>
            </a:xfrm>
            <a:prstGeom prst="straightConnector1">
              <a:avLst/>
            </a:prstGeom>
            <a:ln w="316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96" name="直線矢印コネクタ 53"/>
            <p:cNvCxnSpPr/>
            <p:nvPr/>
          </p:nvCxnSpPr>
          <p:spPr>
            <a:xfrm>
              <a:off x="3315960" y="6295680"/>
              <a:ext cx="1080" cy="207000"/>
            </a:xfrm>
            <a:prstGeom prst="straightConnector1">
              <a:avLst/>
            </a:prstGeom>
            <a:ln w="316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97" name="直線矢印コネクタ 55"/>
            <p:cNvCxnSpPr/>
            <p:nvPr/>
          </p:nvCxnSpPr>
          <p:spPr>
            <a:xfrm>
              <a:off x="4073040" y="3914640"/>
              <a:ext cx="1080" cy="7200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98" name="直線矢印コネクタ 56"/>
            <p:cNvCxnSpPr/>
            <p:nvPr/>
          </p:nvCxnSpPr>
          <p:spPr>
            <a:xfrm>
              <a:off x="4282560" y="3919680"/>
              <a:ext cx="1080" cy="7200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99" name="直線矢印コネクタ 57"/>
            <p:cNvCxnSpPr/>
            <p:nvPr/>
          </p:nvCxnSpPr>
          <p:spPr>
            <a:xfrm>
              <a:off x="4492440" y="3924360"/>
              <a:ext cx="1080" cy="7200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100" name="直線矢印コネクタ 58"/>
            <p:cNvCxnSpPr/>
            <p:nvPr/>
          </p:nvCxnSpPr>
          <p:spPr>
            <a:xfrm>
              <a:off x="4692240" y="3929040"/>
              <a:ext cx="1080" cy="7200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101" name="直線矢印コネクタ 59"/>
            <p:cNvCxnSpPr/>
            <p:nvPr/>
          </p:nvCxnSpPr>
          <p:spPr>
            <a:xfrm>
              <a:off x="4925880" y="3933720"/>
              <a:ext cx="1080" cy="7200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</p:grpSp>
      <p:sp>
        <p:nvSpPr>
          <p:cNvPr id="102" name="TextBox 1"/>
          <p:cNvSpPr/>
          <p:nvPr/>
        </p:nvSpPr>
        <p:spPr>
          <a:xfrm>
            <a:off x="208080" y="27000"/>
            <a:ext cx="638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70c0"/>
                </a:solidFill>
                <a:latin typeface="Calibri"/>
              </a:rPr>
              <a:t>Large-scale proteomic analysis of human kidney glomerulu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Straight Connector 3"/>
          <p:cNvSpPr/>
          <p:nvPr/>
        </p:nvSpPr>
        <p:spPr>
          <a:xfrm>
            <a:off x="193680" y="357120"/>
            <a:ext cx="6323040" cy="3240"/>
          </a:xfrm>
          <a:prstGeom prst="line">
            <a:avLst/>
          </a:prstGeom>
          <a:ln w="57240">
            <a:solidFill>
              <a:srgbClr val="b9cde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テキスト ボックス 54"/>
          <p:cNvSpPr/>
          <p:nvPr/>
        </p:nvSpPr>
        <p:spPr>
          <a:xfrm>
            <a:off x="4059360" y="8761320"/>
            <a:ext cx="273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dditional file 1.1 Cui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テキスト ボックス 4"/>
          <p:cNvSpPr/>
          <p:nvPr/>
        </p:nvSpPr>
        <p:spPr>
          <a:xfrm>
            <a:off x="322200" y="584280"/>
            <a:ext cx="36115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Mass spectromete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テキスト ボックス 5"/>
          <p:cNvSpPr/>
          <p:nvPr/>
        </p:nvSpPr>
        <p:spPr>
          <a:xfrm>
            <a:off x="509760" y="969840"/>
            <a:ext cx="608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anoflow LC-ion trap-MS (Agilent 1100 LC/MSD Trap XCT Ultr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テキスト ボックス 8"/>
          <p:cNvSpPr/>
          <p:nvPr/>
        </p:nvSpPr>
        <p:spPr>
          <a:xfrm>
            <a:off x="320760" y="1405080"/>
            <a:ext cx="23875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Solven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テキスト ボックス 9"/>
          <p:cNvSpPr/>
          <p:nvPr/>
        </p:nvSpPr>
        <p:spPr>
          <a:xfrm>
            <a:off x="509760" y="1790640"/>
            <a:ext cx="58719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Mobile Phase A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: 0.1 % formic aci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Mobile Phase B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: 0.1 % formic acid in acetonitri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テキスト ボックス 10"/>
          <p:cNvSpPr/>
          <p:nvPr/>
        </p:nvSpPr>
        <p:spPr>
          <a:xfrm>
            <a:off x="322200" y="2654280"/>
            <a:ext cx="42861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Nanoflow LC condition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テキスト ボックス 11"/>
          <p:cNvSpPr/>
          <p:nvPr/>
        </p:nvSpPr>
        <p:spPr>
          <a:xfrm>
            <a:off x="723960" y="3422520"/>
            <a:ext cx="56214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Trap column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: 40 nL, ZORBAX 300 SB-C18, 5 </a:t>
            </a: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 (Agilen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Separation column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:  ZORBAX 300 SB-C18, 5 </a:t>
            </a: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, 0.075 ×150 mm (Agilen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テキスト ボックス 14"/>
          <p:cNvSpPr/>
          <p:nvPr/>
        </p:nvSpPr>
        <p:spPr>
          <a:xfrm>
            <a:off x="320760" y="4449600"/>
            <a:ext cx="152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Calibri"/>
              </a:rPr>
              <a:t>Gradien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テキスト ボックス 17"/>
          <p:cNvSpPr/>
          <p:nvPr/>
        </p:nvSpPr>
        <p:spPr>
          <a:xfrm>
            <a:off x="2798640" y="4459320"/>
            <a:ext cx="358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Calibri"/>
              </a:rPr>
              <a:t>MS and MS/MS data acquisi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テキスト ボックス 18"/>
          <p:cNvSpPr/>
          <p:nvPr/>
        </p:nvSpPr>
        <p:spPr>
          <a:xfrm>
            <a:off x="2798640" y="4827600"/>
            <a:ext cx="3943440" cy="393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66760" indent="-266760">
              <a:lnSpc>
                <a:spcPct val="100000"/>
              </a:lnSpc>
              <a:buSzPct val="102812"/>
              <a:buBlip>
                <a:blip r:embed="rId1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wo consecutive LC runs were performed for all the samples followed by two consecutive blank LC runs to eliminate carryover from a previously analyzed sampl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266760" indent="-266760">
              <a:lnSpc>
                <a:spcPct val="100000"/>
              </a:lnSpc>
              <a:buSzPct val="102812"/>
              <a:buBlip>
                <a:blip r:embed="rId2"/>
              </a:buBlip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S/MS data acquisition conditions: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e scan range of MS was set at the range of 350-2000 m/z. Four most intense precursor ions were selected for MS/MS event after a survey MS scan under data-dependent mode. The CID energy was automatically adjusted by the rolling CID function of 6300 Series TrapControl (Agilent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テキスト ボックス 16"/>
          <p:cNvSpPr/>
          <p:nvPr/>
        </p:nvSpPr>
        <p:spPr>
          <a:xfrm>
            <a:off x="587520" y="6562800"/>
            <a:ext cx="2336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Data acquisition time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:</a:t>
            </a:r>
            <a:r>
              <a:rPr b="1" lang="ja-JP" sz="1200" spc="-1" strike="noStrike">
                <a:solidFill>
                  <a:srgbClr val="000000"/>
                </a:solidFill>
                <a:latin typeface="Calibri"/>
              </a:rPr>
              <a:t>　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50 min</a:t>
            </a:r>
            <a:br>
              <a:rPr sz="1200"/>
            </a:b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Flow rate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:</a:t>
            </a:r>
            <a:r>
              <a:rPr b="1" lang="ja-JP" sz="1200" spc="-1" strike="noStrike">
                <a:solidFill>
                  <a:srgbClr val="000000"/>
                </a:solidFill>
                <a:latin typeface="Calibri"/>
              </a:rPr>
              <a:t>　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300 nL/m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1"/>
          <p:cNvSpPr/>
          <p:nvPr/>
        </p:nvSpPr>
        <p:spPr>
          <a:xfrm>
            <a:off x="208080" y="27000"/>
            <a:ext cx="551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70c0"/>
                </a:solidFill>
                <a:latin typeface="Calibri"/>
              </a:rPr>
              <a:t>LC-MS/MS analy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Straight Connector 3"/>
          <p:cNvSpPr/>
          <p:nvPr/>
        </p:nvSpPr>
        <p:spPr>
          <a:xfrm>
            <a:off x="193680" y="509760"/>
            <a:ext cx="6323040" cy="2880"/>
          </a:xfrm>
          <a:prstGeom prst="line">
            <a:avLst/>
          </a:prstGeom>
          <a:ln w="57240">
            <a:solidFill>
              <a:srgbClr val="b9cde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テキスト ボックス 5"/>
          <p:cNvSpPr/>
          <p:nvPr/>
        </p:nvSpPr>
        <p:spPr>
          <a:xfrm>
            <a:off x="512640" y="3032280"/>
            <a:ext cx="601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olumn: HPLC nanospray Chip (Protein ID chip #1, Agilent)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8" name="Picture 2" descr=""/>
          <p:cNvPicPr/>
          <p:nvPr/>
        </p:nvPicPr>
        <p:blipFill>
          <a:blip r:embed="rId3"/>
          <a:stretch/>
        </p:blipFill>
        <p:spPr>
          <a:xfrm>
            <a:off x="333360" y="4835520"/>
            <a:ext cx="2475000" cy="1724040"/>
          </a:xfrm>
          <a:prstGeom prst="rect">
            <a:avLst/>
          </a:prstGeom>
          <a:ln w="0">
            <a:noFill/>
          </a:ln>
        </p:spPr>
      </p:pic>
      <p:sp>
        <p:nvSpPr>
          <p:cNvPr id="119" name="テキスト ボックス 17"/>
          <p:cNvSpPr/>
          <p:nvPr/>
        </p:nvSpPr>
        <p:spPr>
          <a:xfrm>
            <a:off x="4059360" y="8761320"/>
            <a:ext cx="273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dditional file 1.2 Cui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7T05:22:54Z</dcterms:created>
  <dc:creator>Yutaka Yoshida</dc:creator>
  <dc:description/>
  <dc:language>en-US</dc:language>
  <cp:lastModifiedBy>Yutaka Yoshida</cp:lastModifiedBy>
  <dcterms:modified xsi:type="dcterms:W3CDTF">2013-02-18T07:02:45Z</dcterms:modified>
  <cp:revision>12</cp:revision>
  <dc:subject/>
  <dc:title>スライド 1</dc:title>
</cp:coreProperties>
</file>